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>
        <p:scale>
          <a:sx n="199" d="100"/>
          <a:sy n="199" d="100"/>
        </p:scale>
        <p:origin x="520" y="-1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lim, Chinnu" userId="S::chisalim@iu.edu::97f0121d-12bb-4de1-b0c3-9497d3c11a4c" providerId="AD" clId="Web-{FF0FBE18-B0D1-2026-7E45-E6BB83AF8060}"/>
    <pc:docChg chg="modSld">
      <pc:chgData name="Salim, Chinnu" userId="S::chisalim@iu.edu::97f0121d-12bb-4de1-b0c3-9497d3c11a4c" providerId="AD" clId="Web-{FF0FBE18-B0D1-2026-7E45-E6BB83AF8060}" dt="2023-03-01T19:19:18.802" v="36" actId="1076"/>
      <pc:docMkLst>
        <pc:docMk/>
      </pc:docMkLst>
      <pc:sldChg chg="addSp delSp modSp">
        <pc:chgData name="Salim, Chinnu" userId="S::chisalim@iu.edu::97f0121d-12bb-4de1-b0c3-9497d3c11a4c" providerId="AD" clId="Web-{FF0FBE18-B0D1-2026-7E45-E6BB83AF8060}" dt="2023-03-01T19:13:49.607" v="11" actId="1076"/>
        <pc:sldMkLst>
          <pc:docMk/>
          <pc:sldMk cId="4017803071" sldId="256"/>
        </pc:sldMkLst>
        <pc:picChg chg="add mod">
          <ac:chgData name="Salim, Chinnu" userId="S::chisalim@iu.edu::97f0121d-12bb-4de1-b0c3-9497d3c11a4c" providerId="AD" clId="Web-{FF0FBE18-B0D1-2026-7E45-E6BB83AF8060}" dt="2023-03-01T19:13:49.607" v="11" actId="1076"/>
          <ac:picMkLst>
            <pc:docMk/>
            <pc:sldMk cId="4017803071" sldId="256"/>
            <ac:picMk id="3" creationId="{BF74C021-83BD-BB7F-625E-CE345B3C7026}"/>
          </ac:picMkLst>
        </pc:picChg>
        <pc:picChg chg="del">
          <ac:chgData name="Salim, Chinnu" userId="S::chisalim@iu.edu::97f0121d-12bb-4de1-b0c3-9497d3c11a4c" providerId="AD" clId="Web-{FF0FBE18-B0D1-2026-7E45-E6BB83AF8060}" dt="2023-03-01T19:10:43.274" v="0"/>
          <ac:picMkLst>
            <pc:docMk/>
            <pc:sldMk cId="4017803071" sldId="256"/>
            <ac:picMk id="5" creationId="{7D5348C7-9FCD-789D-B2F2-79B15C608A18}"/>
          </ac:picMkLst>
        </pc:picChg>
      </pc:sldChg>
      <pc:sldChg chg="modSp">
        <pc:chgData name="Salim, Chinnu" userId="S::chisalim@iu.edu::97f0121d-12bb-4de1-b0c3-9497d3c11a4c" providerId="AD" clId="Web-{FF0FBE18-B0D1-2026-7E45-E6BB83AF8060}" dt="2023-03-01T19:11:06.509" v="3" actId="1076"/>
        <pc:sldMkLst>
          <pc:docMk/>
          <pc:sldMk cId="332695274" sldId="257"/>
        </pc:sldMkLst>
        <pc:grpChg chg="mod">
          <ac:chgData name="Salim, Chinnu" userId="S::chisalim@iu.edu::97f0121d-12bb-4de1-b0c3-9497d3c11a4c" providerId="AD" clId="Web-{FF0FBE18-B0D1-2026-7E45-E6BB83AF8060}" dt="2023-03-01T19:11:06.509" v="3" actId="1076"/>
          <ac:grpSpMkLst>
            <pc:docMk/>
            <pc:sldMk cId="332695274" sldId="257"/>
            <ac:grpSpMk id="26" creationId="{10754A8B-6964-2DD2-CFE9-D6CC96D3FC7C}"/>
          </ac:grpSpMkLst>
        </pc:grpChg>
      </pc:sldChg>
      <pc:sldChg chg="addSp delSp modSp">
        <pc:chgData name="Salim, Chinnu" userId="S::chisalim@iu.edu::97f0121d-12bb-4de1-b0c3-9497d3c11a4c" providerId="AD" clId="Web-{FF0FBE18-B0D1-2026-7E45-E6BB83AF8060}" dt="2023-03-01T19:19:18.802" v="36" actId="1076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FF0FBE18-B0D1-2026-7E45-E6BB83AF8060}" dt="2023-03-01T19:19:18.802" v="36" actId="1076"/>
          <ac:spMkLst>
            <pc:docMk/>
            <pc:sldMk cId="288543358" sldId="258"/>
            <ac:spMk id="7" creationId="{04D67A3E-B03D-19D7-7690-E78FEB45FDF3}"/>
          </ac:spMkLst>
        </pc:spChg>
        <pc:grpChg chg="del">
          <ac:chgData name="Salim, Chinnu" userId="S::chisalim@iu.edu::97f0121d-12bb-4de1-b0c3-9497d3c11a4c" providerId="AD" clId="Web-{FF0FBE18-B0D1-2026-7E45-E6BB83AF8060}" dt="2023-03-01T19:14:03.045" v="12"/>
          <ac:grpSpMkLst>
            <pc:docMk/>
            <pc:sldMk cId="288543358" sldId="258"/>
            <ac:grpSpMk id="18" creationId="{138E6232-B2D3-4845-A229-EF482531C276}"/>
          </ac:grpSpMkLst>
        </pc:grpChg>
        <pc:picChg chg="add del mod">
          <ac:chgData name="Salim, Chinnu" userId="S::chisalim@iu.edu::97f0121d-12bb-4de1-b0c3-9497d3c11a4c" providerId="AD" clId="Web-{FF0FBE18-B0D1-2026-7E45-E6BB83AF8060}" dt="2023-03-01T19:14:26.842" v="15"/>
          <ac:picMkLst>
            <pc:docMk/>
            <pc:sldMk cId="288543358" sldId="258"/>
            <ac:picMk id="3" creationId="{A06C4993-DAF0-964C-70AE-6D96759D5BC3}"/>
          </ac:picMkLst>
        </pc:picChg>
        <pc:picChg chg="add del mod">
          <ac:chgData name="Salim, Chinnu" userId="S::chisalim@iu.edu::97f0121d-12bb-4de1-b0c3-9497d3c11a4c" providerId="AD" clId="Web-{FF0FBE18-B0D1-2026-7E45-E6BB83AF8060}" dt="2023-03-01T19:15:23.828" v="19"/>
          <ac:picMkLst>
            <pc:docMk/>
            <pc:sldMk cId="288543358" sldId="258"/>
            <ac:picMk id="4" creationId="{6BD9311E-960B-6753-D61F-5067C94C0A9F}"/>
          </ac:picMkLst>
        </pc:picChg>
        <pc:picChg chg="add del mod">
          <ac:chgData name="Salim, Chinnu" userId="S::chisalim@iu.edu::97f0121d-12bb-4de1-b0c3-9497d3c11a4c" providerId="AD" clId="Web-{FF0FBE18-B0D1-2026-7E45-E6BB83AF8060}" dt="2023-03-01T19:18:14.941" v="27"/>
          <ac:picMkLst>
            <pc:docMk/>
            <pc:sldMk cId="288543358" sldId="258"/>
            <ac:picMk id="5" creationId="{EE41C7A4-86AE-E0A1-A68C-51729C76CA09}"/>
          </ac:picMkLst>
        </pc:picChg>
        <pc:picChg chg="add mod">
          <ac:chgData name="Salim, Chinnu" userId="S::chisalim@iu.edu::97f0121d-12bb-4de1-b0c3-9497d3c11a4c" providerId="AD" clId="Web-{FF0FBE18-B0D1-2026-7E45-E6BB83AF8060}" dt="2023-03-01T19:19:14.802" v="35" actId="1076"/>
          <ac:picMkLst>
            <pc:docMk/>
            <pc:sldMk cId="288543358" sldId="258"/>
            <ac:picMk id="8" creationId="{F3A93107-0411-B9DA-21C7-FC414017B16B}"/>
          </ac:picMkLst>
        </pc:picChg>
      </pc:sldChg>
    </pc:docChg>
  </pc:docChgLst>
  <pc:docChgLst>
    <pc:chgData name="Salim, Chinnu" userId="S::chisalim@iu.edu::97f0121d-12bb-4de1-b0c3-9497d3c11a4c" providerId="AD" clId="Web-{51E1042F-247A-4FB8-ADEB-844842AFBF06}"/>
    <pc:docChg chg="modSld">
      <pc:chgData name="Salim, Chinnu" userId="S::chisalim@iu.edu::97f0121d-12bb-4de1-b0c3-9497d3c11a4c" providerId="AD" clId="Web-{51E1042F-247A-4FB8-ADEB-844842AFBF06}" dt="2023-03-22T03:28:52.355" v="31" actId="20577"/>
      <pc:docMkLst>
        <pc:docMk/>
      </pc:docMkLst>
      <pc:sldChg chg="modSp">
        <pc:chgData name="Salim, Chinnu" userId="S::chisalim@iu.edu::97f0121d-12bb-4de1-b0c3-9497d3c11a4c" providerId="AD" clId="Web-{51E1042F-247A-4FB8-ADEB-844842AFBF06}" dt="2023-03-22T03:28:52.355" v="31" actId="20577"/>
        <pc:sldMkLst>
          <pc:docMk/>
          <pc:sldMk cId="332695274" sldId="257"/>
        </pc:sldMkLst>
        <pc:spChg chg="mod">
          <ac:chgData name="Salim, Chinnu" userId="S::chisalim@iu.edu::97f0121d-12bb-4de1-b0c3-9497d3c11a4c" providerId="AD" clId="Web-{51E1042F-247A-4FB8-ADEB-844842AFBF06}" dt="2023-03-22T03:28:52.355" v="31" actId="20577"/>
          <ac:spMkLst>
            <pc:docMk/>
            <pc:sldMk cId="332695274" sldId="257"/>
            <ac:spMk id="2" creationId="{25445CD6-AE6F-76D9-16C5-9EA1DC66FEA5}"/>
          </ac:spMkLst>
        </pc:spChg>
      </pc:sldChg>
    </pc:docChg>
  </pc:docChgLst>
  <pc:docChgLst>
    <pc:chgData name="Dhakal, Alfa" userId="S::aldhakal@iu.edu::47175381-e0f0-42f2-a909-d585e2a70e98" providerId="AD" clId="Web-{C9769094-1664-7458-3467-0ACCADE5B132}"/>
    <pc:docChg chg="modSld">
      <pc:chgData name="Dhakal, Alfa" userId="S::aldhakal@iu.edu::47175381-e0f0-42f2-a909-d585e2a70e98" providerId="AD" clId="Web-{C9769094-1664-7458-3467-0ACCADE5B132}" dt="2023-03-01T18:22:12.641" v="1" actId="20577"/>
      <pc:docMkLst>
        <pc:docMk/>
      </pc:docMkLst>
      <pc:sldChg chg="modSp">
        <pc:chgData name="Dhakal, Alfa" userId="S::aldhakal@iu.edu::47175381-e0f0-42f2-a909-d585e2a70e98" providerId="AD" clId="Web-{C9769094-1664-7458-3467-0ACCADE5B132}" dt="2023-03-01T18:22:12.641" v="1" actId="20577"/>
        <pc:sldMkLst>
          <pc:docMk/>
          <pc:sldMk cId="4017803071" sldId="256"/>
        </pc:sldMkLst>
        <pc:spChg chg="mod">
          <ac:chgData name="Dhakal, Alfa" userId="S::aldhakal@iu.edu::47175381-e0f0-42f2-a909-d585e2a70e98" providerId="AD" clId="Web-{C9769094-1664-7458-3467-0ACCADE5B132}" dt="2023-03-01T18:22:12.641" v="1" actId="20577"/>
          <ac:spMkLst>
            <pc:docMk/>
            <pc:sldMk cId="4017803071" sldId="256"/>
            <ac:spMk id="6" creationId="{55127381-C2F8-5633-0655-B58217238082}"/>
          </ac:spMkLst>
        </pc:spChg>
      </pc:sldChg>
    </pc:docChg>
  </pc:docChgLst>
  <pc:docChgLst>
    <pc:chgData name="Hundley, Heather Ann" userId="9923bbf4-35ca-4515-b4c1-83653bfb90e1" providerId="ADAL" clId="{419F1402-8F74-D746-8983-E4450AB40523}"/>
    <pc:docChg chg="undo custSel modSld">
      <pc:chgData name="Hundley, Heather Ann" userId="9923bbf4-35ca-4515-b4c1-83653bfb90e1" providerId="ADAL" clId="{419F1402-8F74-D746-8983-E4450AB40523}" dt="2023-07-18T20:02:19.092" v="324" actId="20577"/>
      <pc:docMkLst>
        <pc:docMk/>
      </pc:docMkLst>
      <pc:sldChg chg="modSp mod">
        <pc:chgData name="Hundley, Heather Ann" userId="9923bbf4-35ca-4515-b4c1-83653bfb90e1" providerId="ADAL" clId="{419F1402-8F74-D746-8983-E4450AB40523}" dt="2023-07-18T20:02:19.092" v="324" actId="20577"/>
        <pc:sldMkLst>
          <pc:docMk/>
          <pc:sldMk cId="4017803071" sldId="256"/>
        </pc:sldMkLst>
        <pc:spChg chg="mod">
          <ac:chgData name="Hundley, Heather Ann" userId="9923bbf4-35ca-4515-b4c1-83653bfb90e1" providerId="ADAL" clId="{419F1402-8F74-D746-8983-E4450AB40523}" dt="2023-07-18T20:02:19.092" v="324" actId="20577"/>
          <ac:spMkLst>
            <pc:docMk/>
            <pc:sldMk cId="4017803071" sldId="256"/>
            <ac:spMk id="4" creationId="{26162C9E-04AD-9B9D-3748-625D12A8A099}"/>
          </ac:spMkLst>
        </pc:spChg>
      </pc:sldChg>
    </pc:docChg>
  </pc:docChgLst>
  <pc:docChgLst>
    <pc:chgData name="Salim, Chinnu" userId="S::chisalim@iu.edu::97f0121d-12bb-4de1-b0c3-9497d3c11a4c" providerId="AD" clId="Web-{BB2CEBBB-9A44-929B-BF5D-DB6C526AF12D}"/>
    <pc:docChg chg="modSld">
      <pc:chgData name="Salim, Chinnu" userId="S::chisalim@iu.edu::97f0121d-12bb-4de1-b0c3-9497d3c11a4c" providerId="AD" clId="Web-{BB2CEBBB-9A44-929B-BF5D-DB6C526AF12D}" dt="2023-03-22T20:10:01.107" v="8" actId="1076"/>
      <pc:docMkLst>
        <pc:docMk/>
      </pc:docMkLst>
      <pc:sldChg chg="addSp delSp modSp">
        <pc:chgData name="Salim, Chinnu" userId="S::chisalim@iu.edu::97f0121d-12bb-4de1-b0c3-9497d3c11a4c" providerId="AD" clId="Web-{BB2CEBBB-9A44-929B-BF5D-DB6C526AF12D}" dt="2023-03-22T20:10:01.107" v="8" actId="1076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BB2CEBBB-9A44-929B-BF5D-DB6C526AF12D}" dt="2023-03-22T20:10:01.107" v="8" actId="1076"/>
          <ac:spMkLst>
            <pc:docMk/>
            <pc:sldMk cId="4017803071" sldId="256"/>
            <ac:spMk id="6" creationId="{55127381-C2F8-5633-0655-B58217238082}"/>
          </ac:spMkLst>
        </pc:spChg>
        <pc:picChg chg="del">
          <ac:chgData name="Salim, Chinnu" userId="S::chisalim@iu.edu::97f0121d-12bb-4de1-b0c3-9497d3c11a4c" providerId="AD" clId="Web-{BB2CEBBB-9A44-929B-BF5D-DB6C526AF12D}" dt="2023-03-22T20:09:33.903" v="0"/>
          <ac:picMkLst>
            <pc:docMk/>
            <pc:sldMk cId="4017803071" sldId="256"/>
            <ac:picMk id="3" creationId="{BF74C021-83BD-BB7F-625E-CE345B3C7026}"/>
          </ac:picMkLst>
        </pc:picChg>
        <pc:picChg chg="add mod">
          <ac:chgData name="Salim, Chinnu" userId="S::chisalim@iu.edu::97f0121d-12bb-4de1-b0c3-9497d3c11a4c" providerId="AD" clId="Web-{BB2CEBBB-9A44-929B-BF5D-DB6C526AF12D}" dt="2023-03-22T20:09:55.372" v="7" actId="14100"/>
          <ac:picMkLst>
            <pc:docMk/>
            <pc:sldMk cId="4017803071" sldId="256"/>
            <ac:picMk id="4" creationId="{F77B9F6A-E622-3B63-4450-58870593455F}"/>
          </ac:picMkLst>
        </pc:picChg>
      </pc:sldChg>
    </pc:docChg>
  </pc:docChgLst>
  <pc:docChgLst>
    <pc:chgData name="Salim, Chinnu" userId="S::chisalim@iu.edu::97f0121d-12bb-4de1-b0c3-9497d3c11a4c" providerId="AD" clId="Web-{55546C5B-AE20-B4B7-E9FE-9415B410AA6B}"/>
    <pc:docChg chg="modSld">
      <pc:chgData name="Salim, Chinnu" userId="S::chisalim@iu.edu::97f0121d-12bb-4de1-b0c3-9497d3c11a4c" providerId="AD" clId="Web-{55546C5B-AE20-B4B7-E9FE-9415B410AA6B}" dt="2023-03-22T03:44:25.376" v="24"/>
      <pc:docMkLst>
        <pc:docMk/>
      </pc:docMkLst>
      <pc:sldChg chg="modSp">
        <pc:chgData name="Salim, Chinnu" userId="S::chisalim@iu.edu::97f0121d-12bb-4de1-b0c3-9497d3c11a4c" providerId="AD" clId="Web-{55546C5B-AE20-B4B7-E9FE-9415B410AA6B}" dt="2023-03-22T03:43:50.671" v="22" actId="20577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55546C5B-AE20-B4B7-E9FE-9415B410AA6B}" dt="2023-03-22T03:43:50.671" v="22" actId="20577"/>
          <ac:spMkLst>
            <pc:docMk/>
            <pc:sldMk cId="4017803071" sldId="256"/>
            <ac:spMk id="2" creationId="{BF19D0C4-32CD-1272-4AEF-CB6B76937887}"/>
          </ac:spMkLst>
        </pc:spChg>
        <pc:spChg chg="mod">
          <ac:chgData name="Salim, Chinnu" userId="S::chisalim@iu.edu::97f0121d-12bb-4de1-b0c3-9497d3c11a4c" providerId="AD" clId="Web-{55546C5B-AE20-B4B7-E9FE-9415B410AA6B}" dt="2023-03-22T03:34:59.874" v="18" actId="20577"/>
          <ac:spMkLst>
            <pc:docMk/>
            <pc:sldMk cId="4017803071" sldId="256"/>
            <ac:spMk id="6" creationId="{55127381-C2F8-5633-0655-B58217238082}"/>
          </ac:spMkLst>
        </pc:spChg>
      </pc:sldChg>
      <pc:sldChg chg="delSp modSp">
        <pc:chgData name="Salim, Chinnu" userId="S::chisalim@iu.edu::97f0121d-12bb-4de1-b0c3-9497d3c11a4c" providerId="AD" clId="Web-{55546C5B-AE20-B4B7-E9FE-9415B410AA6B}" dt="2023-03-22T03:44:10.063" v="23"/>
        <pc:sldMkLst>
          <pc:docMk/>
          <pc:sldMk cId="332695274" sldId="257"/>
        </pc:sldMkLst>
        <pc:spChg chg="mod">
          <ac:chgData name="Salim, Chinnu" userId="S::chisalim@iu.edu::97f0121d-12bb-4de1-b0c3-9497d3c11a4c" providerId="AD" clId="Web-{55546C5B-AE20-B4B7-E9FE-9415B410AA6B}" dt="2023-03-22T03:34:23.091" v="17" actId="20577"/>
          <ac:spMkLst>
            <pc:docMk/>
            <pc:sldMk cId="332695274" sldId="257"/>
            <ac:spMk id="2" creationId="{25445CD6-AE6F-76D9-16C5-9EA1DC66FEA5}"/>
          </ac:spMkLst>
        </pc:spChg>
        <pc:spChg chg="del">
          <ac:chgData name="Salim, Chinnu" userId="S::chisalim@iu.edu::97f0121d-12bb-4de1-b0c3-9497d3c11a4c" providerId="AD" clId="Web-{55546C5B-AE20-B4B7-E9FE-9415B410AA6B}" dt="2023-03-22T03:44:10.063" v="23"/>
          <ac:spMkLst>
            <pc:docMk/>
            <pc:sldMk cId="332695274" sldId="257"/>
            <ac:spMk id="3" creationId="{2B9C647D-F5BE-C399-F0D7-F6DA9396E9C8}"/>
          </ac:spMkLst>
        </pc:spChg>
      </pc:sldChg>
      <pc:sldChg chg="delSp modSp">
        <pc:chgData name="Salim, Chinnu" userId="S::chisalim@iu.edu::97f0121d-12bb-4de1-b0c3-9497d3c11a4c" providerId="AD" clId="Web-{55546C5B-AE20-B4B7-E9FE-9415B410AA6B}" dt="2023-03-22T03:44:25.376" v="24"/>
        <pc:sldMkLst>
          <pc:docMk/>
          <pc:sldMk cId="288543358" sldId="258"/>
        </pc:sldMkLst>
        <pc:spChg chg="del">
          <ac:chgData name="Salim, Chinnu" userId="S::chisalim@iu.edu::97f0121d-12bb-4de1-b0c3-9497d3c11a4c" providerId="AD" clId="Web-{55546C5B-AE20-B4B7-E9FE-9415B410AA6B}" dt="2023-03-22T03:44:25.376" v="24"/>
          <ac:spMkLst>
            <pc:docMk/>
            <pc:sldMk cId="288543358" sldId="258"/>
            <ac:spMk id="2" creationId="{BCBFBA4D-0249-A21D-8433-BCB04C33E1DA}"/>
          </ac:spMkLst>
        </pc:spChg>
        <pc:spChg chg="mod">
          <ac:chgData name="Salim, Chinnu" userId="S::chisalim@iu.edu::97f0121d-12bb-4de1-b0c3-9497d3c11a4c" providerId="AD" clId="Web-{55546C5B-AE20-B4B7-E9FE-9415B410AA6B}" dt="2023-03-22T03:33:57.091" v="15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Salim, Chinnu" userId="S::chisalim@iu.edu::97f0121d-12bb-4de1-b0c3-9497d3c11a4c" providerId="AD" clId="Web-{5A444016-A950-D8C8-A2C8-0DF12AD44847}"/>
    <pc:docChg chg="modSld">
      <pc:chgData name="Salim, Chinnu" userId="S::chisalim@iu.edu::97f0121d-12bb-4de1-b0c3-9497d3c11a4c" providerId="AD" clId="Web-{5A444016-A950-D8C8-A2C8-0DF12AD44847}" dt="2023-03-22T19:58:25.993" v="14" actId="1076"/>
      <pc:docMkLst>
        <pc:docMk/>
      </pc:docMkLst>
      <pc:sldChg chg="addSp delSp modSp">
        <pc:chgData name="Salim, Chinnu" userId="S::chisalim@iu.edu::97f0121d-12bb-4de1-b0c3-9497d3c11a4c" providerId="AD" clId="Web-{5A444016-A950-D8C8-A2C8-0DF12AD44847}" dt="2023-03-22T19:58:25.993" v="14" actId="1076"/>
        <pc:sldMkLst>
          <pc:docMk/>
          <pc:sldMk cId="4017803071" sldId="256"/>
        </pc:sldMkLst>
        <pc:spChg chg="add del mod">
          <ac:chgData name="Salim, Chinnu" userId="S::chisalim@iu.edu::97f0121d-12bb-4de1-b0c3-9497d3c11a4c" providerId="AD" clId="Web-{5A444016-A950-D8C8-A2C8-0DF12AD44847}" dt="2023-03-22T19:09:37.025" v="10"/>
          <ac:spMkLst>
            <pc:docMk/>
            <pc:sldMk cId="4017803071" sldId="256"/>
            <ac:spMk id="4" creationId="{CAE95613-2B3F-6E2C-8080-3D2DD06534C2}"/>
          </ac:spMkLst>
        </pc:spChg>
        <pc:spChg chg="mod">
          <ac:chgData name="Salim, Chinnu" userId="S::chisalim@iu.edu::97f0121d-12bb-4de1-b0c3-9497d3c11a4c" providerId="AD" clId="Web-{5A444016-A950-D8C8-A2C8-0DF12AD44847}" dt="2023-03-22T18:33:27.056" v="7" actId="1076"/>
          <ac:spMkLst>
            <pc:docMk/>
            <pc:sldMk cId="4017803071" sldId="256"/>
            <ac:spMk id="6" creationId="{55127381-C2F8-5633-0655-B58217238082}"/>
          </ac:spMkLst>
        </pc:spChg>
        <pc:picChg chg="mod">
          <ac:chgData name="Salim, Chinnu" userId="S::chisalim@iu.edu::97f0121d-12bb-4de1-b0c3-9497d3c11a4c" providerId="AD" clId="Web-{5A444016-A950-D8C8-A2C8-0DF12AD44847}" dt="2023-03-22T19:58:25.993" v="14" actId="1076"/>
          <ac:picMkLst>
            <pc:docMk/>
            <pc:sldMk cId="4017803071" sldId="256"/>
            <ac:picMk id="3" creationId="{BF74C021-83BD-BB7F-625E-CE345B3C7026}"/>
          </ac:picMkLst>
        </pc:picChg>
      </pc:sldChg>
      <pc:sldChg chg="modSp">
        <pc:chgData name="Salim, Chinnu" userId="S::chisalim@iu.edu::97f0121d-12bb-4de1-b0c3-9497d3c11a4c" providerId="AD" clId="Web-{5A444016-A950-D8C8-A2C8-0DF12AD44847}" dt="2023-03-22T19:58:16.508" v="13" actId="20577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5A444016-A950-D8C8-A2C8-0DF12AD44847}" dt="2023-03-22T19:58:16.508" v="13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156153-8435-475E-82F8-D26DF3FBEEC5}" type="datetimeFigureOut">
              <a:rPr lang="en-US" smtClean="0"/>
              <a:t>7/18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D67C22-2072-4A7D-A443-5B07EF0AE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944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7/1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663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7/1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049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7/1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598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7/1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733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7/1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154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7/1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200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7/1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220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7/1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541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7/1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511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7/1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833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7/1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548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74D95-4025-FA49-8DBA-B2DA07A2040A}" type="datetimeFigureOut">
              <a:rPr lang="en-US" smtClean="0"/>
              <a:t>7/1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466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F19D0C4-32CD-1272-4AEF-CB6B76937887}"/>
              </a:ext>
            </a:extLst>
          </p:cNvPr>
          <p:cNvSpPr txBox="1"/>
          <p:nvPr/>
        </p:nvSpPr>
        <p:spPr>
          <a:xfrm>
            <a:off x="250497" y="212899"/>
            <a:ext cx="184731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6162C9E-04AD-9B9D-3748-625D12A8A099}"/>
              </a:ext>
            </a:extLst>
          </p:cNvPr>
          <p:cNvSpPr txBox="1"/>
          <p:nvPr/>
        </p:nvSpPr>
        <p:spPr>
          <a:xfrm>
            <a:off x="162838" y="3669523"/>
            <a:ext cx="7484302" cy="14657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dditional File 1: Fig. S1. </a:t>
            </a:r>
            <a:r>
              <a:rPr lang="en-US" sz="1200" b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ADAR mutant worms are susceptible to </a:t>
            </a:r>
            <a:r>
              <a:rPr lang="en-US" sz="1200" b="1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Pseudomonas</a:t>
            </a:r>
            <a:r>
              <a:rPr lang="en-US" sz="1200" b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infection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. A-H) Survival curves of independent biological replicates for the indicated animals subjected to the slow-killing assay and scored for survival in response to </a:t>
            </a:r>
            <a:r>
              <a:rPr lang="en-US" sz="12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P. aeruginosa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strain (PA14). A-B) Biological replicates </a:t>
            </a:r>
            <a:r>
              <a:rPr lang="en-US" sz="12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nd 3 for the data presented in Figure 1A. C-D) Biological replicates 2 and 3 for data presented in Figure 1B. E-F) Biological replicates 2 and 3 for data presented in Figure 1C. </a:t>
            </a:r>
            <a:r>
              <a:rPr lang="en-US" sz="120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G-H) Biological 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replicates 2 and 3 for data presented in Figure 1D. Statistical significance was determined using OASIS,  </a:t>
            </a:r>
            <a:r>
              <a:rPr lang="en-US" sz="12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&lt;0.001 (***), </a:t>
            </a:r>
            <a:r>
              <a:rPr lang="en-US" sz="12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&lt;0.001 (**) and </a:t>
            </a:r>
            <a:r>
              <a:rPr lang="en-US" sz="12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&lt;0.05 (*)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 descr="A collage of graphs&#10;&#10;Description automatically generated">
            <a:extLst>
              <a:ext uri="{FF2B5EF4-FFF2-40B4-BE49-F238E27FC236}">
                <a16:creationId xmlns:a16="http://schemas.microsoft.com/office/drawing/2014/main" id="{526004DB-C50C-57EC-AA10-32285C2CDB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862" y="100165"/>
            <a:ext cx="6389878" cy="3519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7803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0</TotalTime>
  <Words>125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Alfa</dc:creator>
  <cp:lastModifiedBy>Hundley, Heather Ann</cp:lastModifiedBy>
  <cp:revision>77</cp:revision>
  <cp:lastPrinted>2023-01-31T14:45:13Z</cp:lastPrinted>
  <dcterms:created xsi:type="dcterms:W3CDTF">2022-10-06T21:20:44Z</dcterms:created>
  <dcterms:modified xsi:type="dcterms:W3CDTF">2023-07-18T20:02:25Z</dcterms:modified>
</cp:coreProperties>
</file>